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59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0243B-C9D9-4E37-8A9B-975BA0714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714692-240B-41C5-8C90-F164BAD8D7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9EF380-C5C3-4129-8EEE-D4E623AC8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B1000-A6C0-4C62-B2EA-1FD1D9783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E3F364-DC77-44FD-8491-23302B6B0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6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54C79-CE91-4E61-8E4D-D33854ED0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DFD16E-473E-4D8B-A930-A65036E80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A1B09-20F6-48E8-B7A4-59C60E4C6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38E91-8B3C-42C4-81BA-2A528F65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8CFB91-036B-455E-ADB7-9BCA99A4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75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F64375-249E-4A22-B075-930765B156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D4BDBB-E397-401F-81CC-ACD122A42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2B769-92F2-4A7C-A9AE-92647EE7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78F82-22F3-4700-905C-B8BF30FA6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A028F0-7A7E-4402-8B38-E013B57CE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94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32A81-633D-4770-80E3-A7A9DDD1B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7CBB39-00E4-41AC-A959-E946ABF61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56EC8-08E9-44FD-BCFA-0F41EB31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44FEB1-A99B-445C-9FDD-26525761A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1EB348-1246-4E52-9BF8-63186A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5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2F3AAD-9A47-4021-9DD9-6228DA476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04A4F6-104B-419C-BB48-F4C993E0F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BA6A41-D01F-42A5-A0CB-C3858E78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6E1E1-1D4E-46ED-ABE7-9809687F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CF9A44-A457-4832-BF3D-DD4F4B1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45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DFBED2-9502-4A6E-9B63-6FD5D4C81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38064D-07F7-4F1C-B27F-2EBBE2CB19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DBD82-67F9-480E-9432-3763B19B37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2A9A7C-C81A-4CA4-975E-A60478CC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2C19B-593E-4BA2-BB98-C13F5328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9C6D4-056C-4CB7-A498-2298945D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1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32F730-5371-47F1-B409-A5EA0A7D7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530FC-E9BF-4073-8401-C6C23EF02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936AD0-1C01-439A-B5AA-D0CF7C96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7F032-1417-4983-B5B7-DBC3D6FFD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EC7F1C-5D7C-4352-B083-8B2D581E6D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578B67B-AF5E-4672-9A72-D4789F00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85725B8-1C48-419D-B7F3-8927ABCAA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102D0-C63F-4A18-A7D1-BA31B9A8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3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59908-829A-456D-96A3-24686DDA2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86B67D-AF34-4215-A1F8-513DA471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0DA581-5376-4789-9A85-EE2D12191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3051E-C5C3-47E4-A22A-EB298DC97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717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BEF6F9-93DC-4307-9D39-F0E43AF5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19725D-91E4-4FEE-8026-BE495B9B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FA0E68-5D0B-4062-AD51-69B71FEF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5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426F6B-2031-490C-A5A1-65A46833B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BFA83-4F0E-48B7-A0D0-99003B025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5C5ED-0C58-4A9C-AFAC-BDAC71E895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E7E3A4-5DDB-4572-BEE1-ADA34AA1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C9AD49-1057-4906-AD26-A3BF50F4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353386-48BC-441A-AF4F-EA28190F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9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4EF8F9-F59E-4069-8FE5-2FE2FE57F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A3F154-31B2-4BEE-94E9-6B8D74BAA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A9FAF-7263-4725-A1FD-9E39D8EFA0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23A9AF-2003-4B75-81D2-AA19AE85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697D45-5293-4E16-AD0B-CFCBA799F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DA7F62-83E4-4285-8BB4-718119A4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479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B0D66-E7A9-404C-802C-1EBC6B2D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3C41F8-CAC3-4F72-B536-F69A4C9D7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2B3CA-E3A6-4CCE-9F05-A2E288C4A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4F2E-532A-4F73-B9F5-358176767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CDDD7-43F4-42EC-A33C-A6605D461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41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10" Type="http://schemas.openxmlformats.org/officeDocument/2006/relationships/image" Target="../media/image27.tiff"/><Relationship Id="rId4" Type="http://schemas.openxmlformats.org/officeDocument/2006/relationships/image" Target="../media/image21.tiff"/><Relationship Id="rId9" Type="http://schemas.openxmlformats.org/officeDocument/2006/relationships/image" Target="../media/image2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tiff"/><Relationship Id="rId3" Type="http://schemas.openxmlformats.org/officeDocument/2006/relationships/image" Target="../media/image29.tiff"/><Relationship Id="rId7" Type="http://schemas.openxmlformats.org/officeDocument/2006/relationships/image" Target="../media/image33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10" Type="http://schemas.openxmlformats.org/officeDocument/2006/relationships/image" Target="../media/image36.tiff"/><Relationship Id="rId4" Type="http://schemas.openxmlformats.org/officeDocument/2006/relationships/image" Target="../media/image30.tiff"/><Relationship Id="rId9" Type="http://schemas.openxmlformats.org/officeDocument/2006/relationships/image" Target="../media/image3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1F2BBAD-6F5C-4459-A986-4918DC6129A0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3F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62C4A04-0726-4D3E-BDF1-2863E64A56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5625" y="1847850"/>
            <a:ext cx="1440000" cy="144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A105F39-1554-42C1-BEFB-30B4A55573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5625" y="3345000"/>
            <a:ext cx="1440000" cy="144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4F4EE32-44E3-4872-824E-0ABF95B7C1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5625" y="4842150"/>
            <a:ext cx="1440000" cy="144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22D94BA-41F3-4C8D-8F58-EACCB73076C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0250" y="1847850"/>
            <a:ext cx="1440000" cy="144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DF784CCC-CDCF-442C-8237-C33EB61732A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0250" y="3345000"/>
            <a:ext cx="1440000" cy="144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0E4A1D9-D1C3-4FE6-B9CA-2912D770600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0250" y="4842150"/>
            <a:ext cx="1440000" cy="144000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800A7D6-ECBC-4E8D-92F1-6F18AE95F19C}"/>
              </a:ext>
            </a:extLst>
          </p:cNvPr>
          <p:cNvSpPr txBox="1"/>
          <p:nvPr/>
        </p:nvSpPr>
        <p:spPr>
          <a:xfrm>
            <a:off x="8493102" y="3796338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strin2 shRNA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FC1FB21-381D-4961-9FCF-65E51595B9D1}"/>
              </a:ext>
            </a:extLst>
          </p:cNvPr>
          <p:cNvSpPr txBox="1"/>
          <p:nvPr/>
        </p:nvSpPr>
        <p:spPr>
          <a:xfrm>
            <a:off x="3771900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083AF60-82AF-42F8-8F81-3FAA287CE88D}"/>
              </a:ext>
            </a:extLst>
          </p:cNvPr>
          <p:cNvSpPr txBox="1"/>
          <p:nvPr/>
        </p:nvSpPr>
        <p:spPr>
          <a:xfrm>
            <a:off x="5339625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E7F4C9E-BCE1-44B8-9F63-6AD428D590B6}"/>
              </a:ext>
            </a:extLst>
          </p:cNvPr>
          <p:cNvSpPr txBox="1"/>
          <p:nvPr/>
        </p:nvSpPr>
        <p:spPr>
          <a:xfrm>
            <a:off x="7244625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35282A4A-1422-4B01-AD3C-897C68050C5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025" y="3345000"/>
            <a:ext cx="1440000" cy="14400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CBF3E82C-8B5E-4491-AA16-BAEAA498CFD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025" y="4851675"/>
            <a:ext cx="1440000" cy="1440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4C94FDBF-7199-4793-BE18-64AE5C9C469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025" y="1838325"/>
            <a:ext cx="1440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4330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5CCDCF9-2228-4A4E-81B0-474C4D8937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0" y="1752600"/>
            <a:ext cx="1440000" cy="144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2E115E0-D094-47F7-9A89-302F1FBCAB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0" y="3305175"/>
            <a:ext cx="1440000" cy="14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142AE40-1C81-4CC2-9E35-18FE4BEAD3D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0" y="4857750"/>
            <a:ext cx="1440000" cy="14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16D4843-616F-4B45-BFB1-961662E1F53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525" y="3305175"/>
            <a:ext cx="1440000" cy="14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71AD108-65DC-4C5D-99BB-05E3F21253B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525" y="1752600"/>
            <a:ext cx="1440000" cy="144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495D58A-944F-4E81-8787-92E6DCC73BF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525" y="4857750"/>
            <a:ext cx="1440000" cy="14400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B8EEECFE-F1A4-47B7-81A2-B159B1DF008E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3F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2F5FB37-B9A0-42E1-B264-C06C1BC0E8D8}"/>
              </a:ext>
            </a:extLst>
          </p:cNvPr>
          <p:cNvSpPr txBox="1"/>
          <p:nvPr/>
        </p:nvSpPr>
        <p:spPr>
          <a:xfrm>
            <a:off x="8493102" y="3796338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 shRNA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6013C2B-4DBB-4643-8EB5-224950254E9A}"/>
              </a:ext>
            </a:extLst>
          </p:cNvPr>
          <p:cNvSpPr txBox="1"/>
          <p:nvPr/>
        </p:nvSpPr>
        <p:spPr>
          <a:xfrm>
            <a:off x="3781425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3625411-9EF0-4C64-9310-3EA59F484920}"/>
              </a:ext>
            </a:extLst>
          </p:cNvPr>
          <p:cNvSpPr txBox="1"/>
          <p:nvPr/>
        </p:nvSpPr>
        <p:spPr>
          <a:xfrm>
            <a:off x="5520600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D7D177B-F811-442E-A13F-BFC8D0C4075C}"/>
              </a:ext>
            </a:extLst>
          </p:cNvPr>
          <p:cNvSpPr txBox="1"/>
          <p:nvPr/>
        </p:nvSpPr>
        <p:spPr>
          <a:xfrm>
            <a:off x="7244625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EB49CFAC-CF26-4FD0-B50C-AA64EF07E79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6338" y="1739175"/>
            <a:ext cx="1440000" cy="14400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A4CED646-FD68-4ED7-909C-01A2930CFC0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6338" y="4857750"/>
            <a:ext cx="1440000" cy="1440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23CA0767-3298-4E92-B43B-2CD5F6D6BEF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6338" y="3305175"/>
            <a:ext cx="1440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32920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709C3CD-53D0-4738-9AF5-5B8573415A89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4G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4536615-5681-4A6F-9BB2-85F43A1BA1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4925" y="1619250"/>
            <a:ext cx="1440000" cy="144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6C6FB1B-56E4-4C18-B381-69D5B7CBA8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4925" y="3158851"/>
            <a:ext cx="1440000" cy="144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B490ED2-DB8A-4A15-88D3-71BCD9A48B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4925" y="4717502"/>
            <a:ext cx="1440000" cy="144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1D17DD0-F025-4B1A-AC1A-37DADE96C4D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4650" y="1619250"/>
            <a:ext cx="1440000" cy="144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18E36FB-8239-4284-811E-93A5AF1EB73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4650" y="3158851"/>
            <a:ext cx="1440000" cy="144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E6A5C394-4F08-4B0B-9545-8DB2ACBD463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0750" y="4717502"/>
            <a:ext cx="1440000" cy="144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1BBC404-C8B2-435C-8D65-B61E67CB8A4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200" y="1619250"/>
            <a:ext cx="1440000" cy="144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703F39D-A105-4FB6-9E0E-E645C799881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200" y="3158851"/>
            <a:ext cx="1440000" cy="144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FA07256C-0785-4AC1-8D0D-67EB35C8788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200" y="4717502"/>
            <a:ext cx="1440000" cy="1440000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27554787-0866-40F3-A908-122992B0A73E}"/>
              </a:ext>
            </a:extLst>
          </p:cNvPr>
          <p:cNvSpPr txBox="1"/>
          <p:nvPr/>
        </p:nvSpPr>
        <p:spPr>
          <a:xfrm>
            <a:off x="8493102" y="3577263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pHBLV</a:t>
            </a:r>
            <a:r>
              <a:rPr lang="en-US" altLang="zh-CN" dirty="0"/>
              <a:t> sestrin2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293B622-783A-4909-8144-51BEBA89D9FB}"/>
              </a:ext>
            </a:extLst>
          </p:cNvPr>
          <p:cNvSpPr txBox="1"/>
          <p:nvPr/>
        </p:nvSpPr>
        <p:spPr>
          <a:xfrm>
            <a:off x="4029075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18F01EA-2FDD-4A69-8B18-FA38184605A8}"/>
              </a:ext>
            </a:extLst>
          </p:cNvPr>
          <p:cNvSpPr txBox="1"/>
          <p:nvPr/>
        </p:nvSpPr>
        <p:spPr>
          <a:xfrm>
            <a:off x="5596800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FC4CCC5-7B74-42C9-90B9-54D4090C68A2}"/>
              </a:ext>
            </a:extLst>
          </p:cNvPr>
          <p:cNvSpPr txBox="1"/>
          <p:nvPr/>
        </p:nvSpPr>
        <p:spPr>
          <a:xfrm>
            <a:off x="7177950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449759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55D381C-58F8-40BF-A4FF-0ADA6C1665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900" y="1813650"/>
            <a:ext cx="1440000" cy="144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1148B40-6906-4998-8896-C08300240A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900" y="3352800"/>
            <a:ext cx="1440000" cy="144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AA7C699-C310-441E-9920-CA3611174323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4G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EFFF862B-8500-4074-960E-01E34903CB0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900" y="4907100"/>
            <a:ext cx="1440000" cy="144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F381AA0-9435-43A8-A32F-70623035F111}"/>
              </a:ext>
            </a:extLst>
          </p:cNvPr>
          <p:cNvSpPr txBox="1"/>
          <p:nvPr/>
        </p:nvSpPr>
        <p:spPr>
          <a:xfrm>
            <a:off x="8532834" y="3888134"/>
            <a:ext cx="1728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pHBLV</a:t>
            </a:r>
            <a:r>
              <a:rPr lang="en-US" altLang="zh-CN" dirty="0"/>
              <a:t> control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EC14631-799B-4218-8798-6C3FE8C07995}"/>
              </a:ext>
            </a:extLst>
          </p:cNvPr>
          <p:cNvSpPr txBox="1"/>
          <p:nvPr/>
        </p:nvSpPr>
        <p:spPr>
          <a:xfrm>
            <a:off x="4029075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14F08D5-1917-4630-A2F7-EBC90A959695}"/>
              </a:ext>
            </a:extLst>
          </p:cNvPr>
          <p:cNvSpPr txBox="1"/>
          <p:nvPr/>
        </p:nvSpPr>
        <p:spPr>
          <a:xfrm>
            <a:off x="5596800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893B087-486A-4402-84FB-866D5B690F4B}"/>
              </a:ext>
            </a:extLst>
          </p:cNvPr>
          <p:cNvSpPr txBox="1"/>
          <p:nvPr/>
        </p:nvSpPr>
        <p:spPr>
          <a:xfrm>
            <a:off x="7177950" y="1131267"/>
            <a:ext cx="69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ABB407C3-A8D2-42FE-B5B2-CA6F9419A46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5612" y="1813650"/>
            <a:ext cx="1440000" cy="144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73177623-BDD7-42EA-9D12-934B790DF0F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5612" y="3352800"/>
            <a:ext cx="1440000" cy="144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F355C70-813F-4305-8D0E-31F28163479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5612" y="4907100"/>
            <a:ext cx="1440000" cy="144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DEAE2DC9-C435-415A-83E2-91B9562D261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9206" y="1813650"/>
            <a:ext cx="1440000" cy="14400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BCCAA084-BE70-4870-A376-17754520D22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8390" y="3352800"/>
            <a:ext cx="1440000" cy="1440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AF1D17C1-F951-43A4-8B6F-E8CCA72B675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8256" y="4907100"/>
            <a:ext cx="1440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5863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32</Words>
  <Application>Microsoft Office PowerPoint</Application>
  <PresentationFormat>宽屏</PresentationFormat>
  <Paragraphs>2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9</cp:revision>
  <dcterms:created xsi:type="dcterms:W3CDTF">2021-06-15T01:43:45Z</dcterms:created>
  <dcterms:modified xsi:type="dcterms:W3CDTF">2021-06-15T02:52:49Z</dcterms:modified>
</cp:coreProperties>
</file>